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  <p:sldMasterId id="2147483684" r:id="rId2"/>
  </p:sldMasterIdLst>
  <p:sldIdLst>
    <p:sldId id="271" r:id="rId3"/>
    <p:sldId id="256" r:id="rId4"/>
    <p:sldId id="275" r:id="rId5"/>
    <p:sldId id="276" r:id="rId6"/>
    <p:sldId id="278" r:id="rId7"/>
    <p:sldId id="273" r:id="rId8"/>
    <p:sldId id="277" r:id="rId9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44" d="100"/>
          <a:sy n="44" d="100"/>
        </p:scale>
        <p:origin x="1004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viewProps" Target="viewProps.xml"/><Relationship Id="rId5" Type="http://schemas.openxmlformats.org/officeDocument/2006/relationships/slide" Target="slides/slide3.xml"/><Relationship Id="rId10" Type="http://schemas.openxmlformats.org/officeDocument/2006/relationships/presProps" Target="presProps.xml"/><Relationship Id="rId4" Type="http://schemas.openxmlformats.org/officeDocument/2006/relationships/slide" Target="slides/slide2.xml"/><Relationship Id="rId9" Type="http://schemas.openxmlformats.org/officeDocument/2006/relationships/slide" Target="slides/slide7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4E794-5AC7-4261-8675-597BEE5FBDBD}" type="datetimeFigureOut">
              <a:rPr lang="zh-CN" altLang="en-US" smtClean="0"/>
              <a:t>2022/2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A4F8-3BE4-4E5D-9424-957A1833AA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39885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4E794-5AC7-4261-8675-597BEE5FBDBD}" type="datetimeFigureOut">
              <a:rPr lang="zh-CN" altLang="en-US" smtClean="0"/>
              <a:t>2022/2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A4F8-3BE4-4E5D-9424-957A1833AA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07101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4E794-5AC7-4261-8675-597BEE5FBDBD}" type="datetimeFigureOut">
              <a:rPr lang="zh-CN" altLang="en-US" smtClean="0"/>
              <a:t>2022/2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A4F8-3BE4-4E5D-9424-957A1833AA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501252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565C-122C-453D-84CC-526CCCCB2DE1}" type="datetimeFigureOut">
              <a:rPr lang="zh-CN" altLang="en-US" smtClean="0"/>
              <a:t>2022/2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4916F-36A2-4D4A-AD3E-B6A7363FA2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9423017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565C-122C-453D-84CC-526CCCCB2DE1}" type="datetimeFigureOut">
              <a:rPr lang="zh-CN" altLang="en-US" smtClean="0"/>
              <a:t>2022/2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4916F-36A2-4D4A-AD3E-B6A7363FA2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317399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565C-122C-453D-84CC-526CCCCB2DE1}" type="datetimeFigureOut">
              <a:rPr lang="zh-CN" altLang="en-US" smtClean="0"/>
              <a:t>2022/2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4916F-36A2-4D4A-AD3E-B6A7363FA2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0012719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565C-122C-453D-84CC-526CCCCB2DE1}" type="datetimeFigureOut">
              <a:rPr lang="zh-CN" altLang="en-US" smtClean="0"/>
              <a:t>2022/2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4916F-36A2-4D4A-AD3E-B6A7363FA2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8320945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565C-122C-453D-84CC-526CCCCB2DE1}" type="datetimeFigureOut">
              <a:rPr lang="zh-CN" altLang="en-US" smtClean="0"/>
              <a:t>2022/2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4916F-36A2-4D4A-AD3E-B6A7363FA2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0694673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565C-122C-453D-84CC-526CCCCB2DE1}" type="datetimeFigureOut">
              <a:rPr lang="zh-CN" altLang="en-US" smtClean="0"/>
              <a:t>2022/2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4916F-36A2-4D4A-AD3E-B6A7363FA2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040347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565C-122C-453D-84CC-526CCCCB2DE1}" type="datetimeFigureOut">
              <a:rPr lang="zh-CN" altLang="en-US" smtClean="0"/>
              <a:t>2022/2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4916F-36A2-4D4A-AD3E-B6A7363FA2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2481161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565C-122C-453D-84CC-526CCCCB2DE1}" type="datetimeFigureOut">
              <a:rPr lang="zh-CN" altLang="en-US" smtClean="0"/>
              <a:t>2022/2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4916F-36A2-4D4A-AD3E-B6A7363FA2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68277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4E794-5AC7-4261-8675-597BEE5FBDBD}" type="datetimeFigureOut">
              <a:rPr lang="zh-CN" altLang="en-US" smtClean="0"/>
              <a:t>2022/2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A4F8-3BE4-4E5D-9424-957A1833AA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174194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565C-122C-453D-84CC-526CCCCB2DE1}" type="datetimeFigureOut">
              <a:rPr lang="zh-CN" altLang="en-US" smtClean="0"/>
              <a:t>2022/2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4916F-36A2-4D4A-AD3E-B6A7363FA2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47290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565C-122C-453D-84CC-526CCCCB2DE1}" type="datetimeFigureOut">
              <a:rPr lang="zh-CN" altLang="en-US" smtClean="0"/>
              <a:t>2022/2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4916F-36A2-4D4A-AD3E-B6A7363FA2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3162322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565C-122C-453D-84CC-526CCCCB2DE1}" type="datetimeFigureOut">
              <a:rPr lang="zh-CN" altLang="en-US" smtClean="0"/>
              <a:t>2022/2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4916F-36A2-4D4A-AD3E-B6A7363FA2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47403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4E794-5AC7-4261-8675-597BEE5FBDBD}" type="datetimeFigureOut">
              <a:rPr lang="zh-CN" altLang="en-US" smtClean="0"/>
              <a:t>2022/2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A4F8-3BE4-4E5D-9424-957A1833AA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41667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4E794-5AC7-4261-8675-597BEE5FBDBD}" type="datetimeFigureOut">
              <a:rPr lang="zh-CN" altLang="en-US" smtClean="0"/>
              <a:t>2022/2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A4F8-3BE4-4E5D-9424-957A1833AA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97227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4E794-5AC7-4261-8675-597BEE5FBDBD}" type="datetimeFigureOut">
              <a:rPr lang="zh-CN" altLang="en-US" smtClean="0"/>
              <a:t>2022/2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A4F8-3BE4-4E5D-9424-957A1833AA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87568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4E794-5AC7-4261-8675-597BEE5FBDBD}" type="datetimeFigureOut">
              <a:rPr lang="zh-CN" altLang="en-US" smtClean="0"/>
              <a:t>2022/2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A4F8-3BE4-4E5D-9424-957A1833AA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18598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4E794-5AC7-4261-8675-597BEE5FBDBD}" type="datetimeFigureOut">
              <a:rPr lang="zh-CN" altLang="en-US" smtClean="0"/>
              <a:t>2022/2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A4F8-3BE4-4E5D-9424-957A1833AA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41820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4E794-5AC7-4261-8675-597BEE5FBDBD}" type="datetimeFigureOut">
              <a:rPr lang="zh-CN" altLang="en-US" smtClean="0"/>
              <a:t>2022/2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A4F8-3BE4-4E5D-9424-957A1833AA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10709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4E794-5AC7-4261-8675-597BEE5FBDBD}" type="datetimeFigureOut">
              <a:rPr lang="zh-CN" altLang="en-US" smtClean="0"/>
              <a:t>2022/2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FFA4F8-3BE4-4E5D-9424-957A1833AA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944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04E794-5AC7-4261-8675-597BEE5FBDBD}" type="datetimeFigureOut">
              <a:rPr lang="zh-CN" altLang="en-US" smtClean="0"/>
              <a:t>2022/2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FFA4F8-3BE4-4E5D-9424-957A1833AA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32330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33565C-122C-453D-84CC-526CCCCB2DE1}" type="datetimeFigureOut">
              <a:rPr lang="zh-CN" altLang="en-US" smtClean="0"/>
              <a:t>2022/2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D4916F-36A2-4D4A-AD3E-B6A7363FA2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76910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8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jpg"/><Relationship Id="rId3" Type="http://schemas.openxmlformats.org/officeDocument/2006/relationships/image" Target="../media/image5.jpg"/><Relationship Id="rId7" Type="http://schemas.openxmlformats.org/officeDocument/2006/relationships/image" Target="../media/image9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jpg"/><Relationship Id="rId5" Type="http://schemas.openxmlformats.org/officeDocument/2006/relationships/image" Target="../media/image7.jpg"/><Relationship Id="rId4" Type="http://schemas.openxmlformats.org/officeDocument/2006/relationships/image" Target="../media/image6.jpg"/><Relationship Id="rId9" Type="http://schemas.openxmlformats.org/officeDocument/2006/relationships/image" Target="../media/image11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g"/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6.jpg"/><Relationship Id="rId5" Type="http://schemas.openxmlformats.org/officeDocument/2006/relationships/image" Target="../media/image15.jpg"/><Relationship Id="rId4" Type="http://schemas.openxmlformats.org/officeDocument/2006/relationships/image" Target="../media/image14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g"/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9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g"/><Relationship Id="rId2" Type="http://schemas.openxmlformats.org/officeDocument/2006/relationships/image" Target="../media/image20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jpg"/><Relationship Id="rId5" Type="http://schemas.openxmlformats.org/officeDocument/2006/relationships/image" Target="../media/image23.jpg"/><Relationship Id="rId4" Type="http://schemas.openxmlformats.org/officeDocument/2006/relationships/image" Target="../media/image22.jp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jpg"/><Relationship Id="rId3" Type="http://schemas.openxmlformats.org/officeDocument/2006/relationships/image" Target="../media/image26.jpg"/><Relationship Id="rId7" Type="http://schemas.openxmlformats.org/officeDocument/2006/relationships/image" Target="../media/image30.jpg"/><Relationship Id="rId2" Type="http://schemas.openxmlformats.org/officeDocument/2006/relationships/image" Target="../media/image25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jpg"/><Relationship Id="rId5" Type="http://schemas.openxmlformats.org/officeDocument/2006/relationships/image" Target="../media/image28.jpg"/><Relationship Id="rId4" Type="http://schemas.openxmlformats.org/officeDocument/2006/relationships/image" Target="../media/image27.jpg"/><Relationship Id="rId9" Type="http://schemas.openxmlformats.org/officeDocument/2006/relationships/image" Target="../media/image3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4BC616D0-50A8-1F4F-8DFB-33DB3B0486D8}"/>
              </a:ext>
            </a:extLst>
          </p:cNvPr>
          <p:cNvSpPr/>
          <p:nvPr/>
        </p:nvSpPr>
        <p:spPr>
          <a:xfrm>
            <a:off x="630560" y="2355880"/>
            <a:ext cx="5918415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 Raw Images. Original blot images for  S2C, S2E, S2G, S3E, S4B, S7B, S7C, S8A, S8D, S8H Figs.</a:t>
            </a:r>
            <a:endParaRPr lang="zh-CN" altLang="zh-C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72649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96C1A107-CCDF-4ADD-BE30-153C8DAD3B3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9033" y="822534"/>
            <a:ext cx="3810554" cy="2640122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E59E2615-34C7-4B8E-B425-345EE6DA8CBA}"/>
              </a:ext>
            </a:extLst>
          </p:cNvPr>
          <p:cNvSpPr txBox="1"/>
          <p:nvPr/>
        </p:nvSpPr>
        <p:spPr>
          <a:xfrm>
            <a:off x="2245073" y="3915925"/>
            <a:ext cx="2367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2C  Fig,  second panel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49C1B967-2A39-4603-93E6-368272BDCB68}"/>
              </a:ext>
            </a:extLst>
          </p:cNvPr>
          <p:cNvSpPr txBox="1"/>
          <p:nvPr/>
        </p:nvSpPr>
        <p:spPr>
          <a:xfrm>
            <a:off x="2245073" y="250174"/>
            <a:ext cx="2367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2C Fig, first panel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E26BED6D-CFB4-4BBC-8FB2-2A639E2DDC0D}"/>
              </a:ext>
            </a:extLst>
          </p:cNvPr>
          <p:cNvSpPr txBox="1"/>
          <p:nvPr/>
        </p:nvSpPr>
        <p:spPr>
          <a:xfrm>
            <a:off x="2245073" y="6667049"/>
            <a:ext cx="2367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2C Fig, third panel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36FB7A12-5F29-4ADE-88D5-20AFC5B4600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87" y="7160965"/>
            <a:ext cx="2880360" cy="2161032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1ADB7E6C-2729-4CB3-957D-276D519A366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98068" y="4511043"/>
            <a:ext cx="2276856" cy="1572768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46386B16-63C5-4619-80FB-AA381D9C2399}"/>
              </a:ext>
            </a:extLst>
          </p:cNvPr>
          <p:cNvSpPr txBox="1"/>
          <p:nvPr/>
        </p:nvSpPr>
        <p:spPr>
          <a:xfrm flipH="1">
            <a:off x="3645263" y="2191657"/>
            <a:ext cx="103748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dirty="0">
                <a:solidFill>
                  <a:srgbClr val="FF0000"/>
                </a:solidFill>
                <a:latin typeface="等线" panose="02010600030101010101" pitchFamily="2" charset="-122"/>
                <a:ea typeface="等线" panose="02010600030101010101" pitchFamily="2" charset="-122"/>
              </a:rPr>
              <a:t>ⅹ</a:t>
            </a:r>
            <a:endParaRPr lang="zh-CN" altLang="en-US" sz="3200" dirty="0">
              <a:solidFill>
                <a:srgbClr val="FF0000"/>
              </a:solidFill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C3D8EB77-C850-430A-A03A-F06F4C23E689}"/>
              </a:ext>
            </a:extLst>
          </p:cNvPr>
          <p:cNvSpPr txBox="1"/>
          <p:nvPr/>
        </p:nvSpPr>
        <p:spPr>
          <a:xfrm>
            <a:off x="13669" y="-75860"/>
            <a:ext cx="10305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S2 Fig 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24423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图片 24">
            <a:extLst>
              <a:ext uri="{FF2B5EF4-FFF2-40B4-BE49-F238E27FC236}">
                <a16:creationId xmlns:a16="http://schemas.microsoft.com/office/drawing/2014/main" id="{C5C702C6-D8F9-4D1D-B194-56FE4706558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6202" y="3761409"/>
            <a:ext cx="2266188" cy="95250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CC45F2A0-B2E9-4BCD-B825-391B4C7399E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4441" y="3430513"/>
            <a:ext cx="2375916" cy="1440180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AC2B33EF-2E1F-48B6-AD41-FBA09A50244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4952" y="938295"/>
            <a:ext cx="2700528" cy="1979676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73279429-18D8-4F83-8E2B-72585B85781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5728" y="5565104"/>
            <a:ext cx="3383280" cy="1548384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E59E2615-34C7-4B8E-B425-345EE6DA8CBA}"/>
              </a:ext>
            </a:extLst>
          </p:cNvPr>
          <p:cNvSpPr txBox="1"/>
          <p:nvPr/>
        </p:nvSpPr>
        <p:spPr>
          <a:xfrm>
            <a:off x="3889316" y="616004"/>
            <a:ext cx="2367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2E Fig, second panel.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49C1B967-2A39-4603-93E6-368272BDCB68}"/>
              </a:ext>
            </a:extLst>
          </p:cNvPr>
          <p:cNvSpPr txBox="1"/>
          <p:nvPr/>
        </p:nvSpPr>
        <p:spPr>
          <a:xfrm>
            <a:off x="419286" y="616004"/>
            <a:ext cx="2367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2E Fig, first panel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E26BED6D-CFB4-4BBC-8FB2-2A639E2DDC0D}"/>
              </a:ext>
            </a:extLst>
          </p:cNvPr>
          <p:cNvSpPr txBox="1"/>
          <p:nvPr/>
        </p:nvSpPr>
        <p:spPr>
          <a:xfrm>
            <a:off x="418042" y="3131046"/>
            <a:ext cx="2367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2E Fig, third panel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60A0BC27-C892-4315-890C-B4C23DFE17A4}"/>
              </a:ext>
            </a:extLst>
          </p:cNvPr>
          <p:cNvSpPr txBox="1"/>
          <p:nvPr/>
        </p:nvSpPr>
        <p:spPr>
          <a:xfrm>
            <a:off x="3978385" y="3131046"/>
            <a:ext cx="2367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2E Fig, fourth panel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17">
            <a:extLst>
              <a:ext uri="{FF2B5EF4-FFF2-40B4-BE49-F238E27FC236}">
                <a16:creationId xmlns:a16="http://schemas.microsoft.com/office/drawing/2014/main" id="{E26BED6D-CFB4-4BBC-8FB2-2A639E2DDC0D}"/>
              </a:ext>
            </a:extLst>
          </p:cNvPr>
          <p:cNvSpPr txBox="1"/>
          <p:nvPr/>
        </p:nvSpPr>
        <p:spPr>
          <a:xfrm>
            <a:off x="460812" y="5123546"/>
            <a:ext cx="2367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2G Fig, first panel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E71EDFFE-D605-4906-AB91-80CC381FB1B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7764" y="1024741"/>
            <a:ext cx="2465832" cy="1438656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79772E67-99F4-4CA5-9624-4CDD38511418}"/>
              </a:ext>
            </a:extLst>
          </p:cNvPr>
          <p:cNvSpPr txBox="1"/>
          <p:nvPr/>
        </p:nvSpPr>
        <p:spPr>
          <a:xfrm flipH="1">
            <a:off x="5223700" y="1767909"/>
            <a:ext cx="10374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solidFill>
                  <a:srgbClr val="FF0000"/>
                </a:solidFill>
                <a:latin typeface="等线" panose="02010600030101010101" pitchFamily="2" charset="-122"/>
                <a:ea typeface="等线" panose="02010600030101010101" pitchFamily="2" charset="-122"/>
              </a:rPr>
              <a:t>ⅹ</a:t>
            </a:r>
            <a:endParaRPr lang="zh-CN" altLang="en-US" sz="2400" dirty="0">
              <a:solidFill>
                <a:srgbClr val="FF0000"/>
              </a:solidFill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2F21968F-7DE4-47F0-9A2D-7AB83EC894F8}"/>
              </a:ext>
            </a:extLst>
          </p:cNvPr>
          <p:cNvSpPr txBox="1"/>
          <p:nvPr/>
        </p:nvSpPr>
        <p:spPr>
          <a:xfrm flipH="1">
            <a:off x="5182608" y="3752734"/>
            <a:ext cx="10374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solidFill>
                  <a:srgbClr val="FF0000"/>
                </a:solidFill>
                <a:latin typeface="等线" panose="02010600030101010101" pitchFamily="2" charset="-122"/>
                <a:ea typeface="等线" panose="02010600030101010101" pitchFamily="2" charset="-122"/>
              </a:rPr>
              <a:t>ⅹ</a:t>
            </a:r>
            <a:endParaRPr lang="zh-CN" altLang="en-US" sz="2400" dirty="0">
              <a:solidFill>
                <a:srgbClr val="FF0000"/>
              </a:solidFill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FA9B1C6F-0B02-40D5-B3FB-05101ECA09E6}"/>
              </a:ext>
            </a:extLst>
          </p:cNvPr>
          <p:cNvSpPr txBox="1"/>
          <p:nvPr/>
        </p:nvSpPr>
        <p:spPr>
          <a:xfrm flipH="1">
            <a:off x="554009" y="3356590"/>
            <a:ext cx="1037480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800" dirty="0">
                <a:solidFill>
                  <a:srgbClr val="FF0000"/>
                </a:solidFill>
                <a:latin typeface="等线" panose="02010600030101010101" pitchFamily="2" charset="-122"/>
                <a:ea typeface="等线" panose="02010600030101010101" pitchFamily="2" charset="-122"/>
              </a:rPr>
              <a:t>ⅹ</a:t>
            </a:r>
            <a:endParaRPr lang="zh-CN" altLang="en-US" sz="7800" dirty="0">
              <a:solidFill>
                <a:srgbClr val="FF0000"/>
              </a:solidFill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F5C8846A-A286-421F-A460-A51996921DE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625713"/>
            <a:ext cx="3383280" cy="1548384"/>
          </a:xfrm>
          <a:prstGeom prst="rect">
            <a:avLst/>
          </a:prstGeom>
        </p:spPr>
      </p:pic>
      <p:sp>
        <p:nvSpPr>
          <p:cNvPr id="19" name="文本框 17">
            <a:extLst>
              <a:ext uri="{FF2B5EF4-FFF2-40B4-BE49-F238E27FC236}">
                <a16:creationId xmlns:a16="http://schemas.microsoft.com/office/drawing/2014/main" id="{2AD960C9-95AC-42F2-B9EC-AF2CFA0A396C}"/>
              </a:ext>
            </a:extLst>
          </p:cNvPr>
          <p:cNvSpPr txBox="1"/>
          <p:nvPr/>
        </p:nvSpPr>
        <p:spPr>
          <a:xfrm>
            <a:off x="3966011" y="5130801"/>
            <a:ext cx="2367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2G Fig, second panel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17">
            <a:extLst>
              <a:ext uri="{FF2B5EF4-FFF2-40B4-BE49-F238E27FC236}">
                <a16:creationId xmlns:a16="http://schemas.microsoft.com/office/drawing/2014/main" id="{F1C06D84-32EA-42F6-8C59-3B2CD25D786F}"/>
              </a:ext>
            </a:extLst>
          </p:cNvPr>
          <p:cNvSpPr txBox="1"/>
          <p:nvPr/>
        </p:nvSpPr>
        <p:spPr>
          <a:xfrm>
            <a:off x="453553" y="7351489"/>
            <a:ext cx="2367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2G Fig, third panel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17">
            <a:extLst>
              <a:ext uri="{FF2B5EF4-FFF2-40B4-BE49-F238E27FC236}">
                <a16:creationId xmlns:a16="http://schemas.microsoft.com/office/drawing/2014/main" id="{16728E6B-B0B0-4D82-8911-7B52F108DAFF}"/>
              </a:ext>
            </a:extLst>
          </p:cNvPr>
          <p:cNvSpPr txBox="1"/>
          <p:nvPr/>
        </p:nvSpPr>
        <p:spPr>
          <a:xfrm>
            <a:off x="3765011" y="7351489"/>
            <a:ext cx="28809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2G Fig, fourth and fifth panels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70D5ABEE-19A5-45F1-8B03-C6CC6934BA21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859671"/>
            <a:ext cx="3383280" cy="1548384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27481F37-9E77-4225-BF88-57777106B31A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5384" y="7798062"/>
            <a:ext cx="3599688" cy="2097024"/>
          </a:xfrm>
          <a:prstGeom prst="rect">
            <a:avLst/>
          </a:prstGeom>
        </p:spPr>
      </p:pic>
      <p:sp>
        <p:nvSpPr>
          <p:cNvPr id="24" name="文本框 23">
            <a:extLst>
              <a:ext uri="{FF2B5EF4-FFF2-40B4-BE49-F238E27FC236}">
                <a16:creationId xmlns:a16="http://schemas.microsoft.com/office/drawing/2014/main" id="{35E01A03-DEB9-45C3-A42F-1B9504EBB649}"/>
              </a:ext>
            </a:extLst>
          </p:cNvPr>
          <p:cNvSpPr txBox="1"/>
          <p:nvPr/>
        </p:nvSpPr>
        <p:spPr>
          <a:xfrm>
            <a:off x="14515" y="9202"/>
            <a:ext cx="20465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S2 Fig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041032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A2E28973-6142-412B-AC86-E64474DE029A}"/>
              </a:ext>
            </a:extLst>
          </p:cNvPr>
          <p:cNvSpPr txBox="1"/>
          <p:nvPr/>
        </p:nvSpPr>
        <p:spPr>
          <a:xfrm>
            <a:off x="506560" y="890687"/>
            <a:ext cx="2367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3E Fig, first panel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15">
            <a:extLst>
              <a:ext uri="{FF2B5EF4-FFF2-40B4-BE49-F238E27FC236}">
                <a16:creationId xmlns:a16="http://schemas.microsoft.com/office/drawing/2014/main" id="{49C1B967-2A39-4603-93E6-368272BDCB68}"/>
              </a:ext>
            </a:extLst>
          </p:cNvPr>
          <p:cNvSpPr txBox="1"/>
          <p:nvPr/>
        </p:nvSpPr>
        <p:spPr>
          <a:xfrm>
            <a:off x="3624207" y="883646"/>
            <a:ext cx="2367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3E Fig, second panel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16B5B696-0234-4D48-A0A0-037641F0FB4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560" y="1500807"/>
            <a:ext cx="2051304" cy="108204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5DB44B5C-DD22-4945-AA70-68A526BD0E2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24207" y="1500807"/>
            <a:ext cx="2051304" cy="1082040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A57BDEC6-E88E-415C-BC73-CA6E80A7D66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560" y="3520984"/>
            <a:ext cx="2051304" cy="1082040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2A19DE34-49F1-4585-A97C-1A6322C3A80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7685" y="3520984"/>
            <a:ext cx="2051304" cy="108204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5DADF510-2C97-4274-A142-60654147F50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560" y="5541161"/>
            <a:ext cx="2051304" cy="1082040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E815C273-EF9E-4BDC-977E-EA33C4E065E7}"/>
              </a:ext>
            </a:extLst>
          </p:cNvPr>
          <p:cNvSpPr txBox="1"/>
          <p:nvPr/>
        </p:nvSpPr>
        <p:spPr>
          <a:xfrm>
            <a:off x="513818" y="2828342"/>
            <a:ext cx="2367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3E Fig, third panel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CAE86052-E03D-49AA-88C7-D5172B5BE8E5}"/>
              </a:ext>
            </a:extLst>
          </p:cNvPr>
          <p:cNvSpPr txBox="1"/>
          <p:nvPr/>
        </p:nvSpPr>
        <p:spPr>
          <a:xfrm>
            <a:off x="3624207" y="2828341"/>
            <a:ext cx="2367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3E Fig, fourth panel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ED8C3108-9427-4588-A09D-DB9759404AA3}"/>
              </a:ext>
            </a:extLst>
          </p:cNvPr>
          <p:cNvSpPr txBox="1"/>
          <p:nvPr/>
        </p:nvSpPr>
        <p:spPr>
          <a:xfrm>
            <a:off x="521075" y="4940173"/>
            <a:ext cx="2367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3E Fig, fifth panel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82051F00-C640-4D67-89BD-93DD514B8AE5}"/>
              </a:ext>
            </a:extLst>
          </p:cNvPr>
          <p:cNvSpPr txBox="1"/>
          <p:nvPr/>
        </p:nvSpPr>
        <p:spPr>
          <a:xfrm>
            <a:off x="14515" y="9202"/>
            <a:ext cx="20465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S3 Fig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9078445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图片 15">
            <a:extLst>
              <a:ext uri="{FF2B5EF4-FFF2-40B4-BE49-F238E27FC236}">
                <a16:creationId xmlns:a16="http://schemas.microsoft.com/office/drawing/2014/main" id="{29EB6C6C-F8D9-4EBD-9ED2-3452A2574AD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2427" y="7805172"/>
            <a:ext cx="2784348" cy="1517904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E5252403-B5A8-43C9-8E31-E50123E2341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8654" y="1492769"/>
            <a:ext cx="3617976" cy="1906524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8F8C7521-6234-4869-9AB8-25DC08D58E27}"/>
              </a:ext>
            </a:extLst>
          </p:cNvPr>
          <p:cNvSpPr txBox="1"/>
          <p:nvPr/>
        </p:nvSpPr>
        <p:spPr>
          <a:xfrm>
            <a:off x="2329979" y="1109922"/>
            <a:ext cx="2367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4B Fig, first panel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F135648A-A708-4B31-A476-379A14C9F82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9979" y="4824848"/>
            <a:ext cx="2051304" cy="1438656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A6CFA908-2799-41E1-AFFB-810AF268FCDD}"/>
              </a:ext>
            </a:extLst>
          </p:cNvPr>
          <p:cNvSpPr txBox="1"/>
          <p:nvPr/>
        </p:nvSpPr>
        <p:spPr>
          <a:xfrm>
            <a:off x="2271923" y="4139701"/>
            <a:ext cx="2367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4B Fig, second panel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A520CD3-E313-46E1-A017-7B3CE34657C5}"/>
              </a:ext>
            </a:extLst>
          </p:cNvPr>
          <p:cNvSpPr txBox="1"/>
          <p:nvPr/>
        </p:nvSpPr>
        <p:spPr>
          <a:xfrm>
            <a:off x="2329979" y="7039477"/>
            <a:ext cx="2367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4B Fig, third panel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BD3154A9-22AA-4FAA-BBC7-6C327392BF1B}"/>
              </a:ext>
            </a:extLst>
          </p:cNvPr>
          <p:cNvSpPr txBox="1"/>
          <p:nvPr/>
        </p:nvSpPr>
        <p:spPr>
          <a:xfrm>
            <a:off x="14515" y="9202"/>
            <a:ext cx="20465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S4 Fig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217EE44C-57BA-4932-99EB-18DB75528E53}"/>
              </a:ext>
            </a:extLst>
          </p:cNvPr>
          <p:cNvSpPr txBox="1"/>
          <p:nvPr/>
        </p:nvSpPr>
        <p:spPr>
          <a:xfrm flipH="1">
            <a:off x="4056407" y="2612444"/>
            <a:ext cx="10647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solidFill>
                  <a:srgbClr val="FF0000"/>
                </a:solidFill>
                <a:latin typeface="等线" panose="02010600030101010101" pitchFamily="2" charset="-122"/>
                <a:ea typeface="等线" panose="02010600030101010101" pitchFamily="2" charset="-122"/>
              </a:rPr>
              <a:t>ⅹ</a:t>
            </a:r>
            <a:endParaRPr lang="zh-CN" altLang="en-US" sz="2400" dirty="0">
              <a:solidFill>
                <a:srgbClr val="FF0000"/>
              </a:solidFill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914D26A7-DCA2-4E0A-8329-B32211595D9B}"/>
              </a:ext>
            </a:extLst>
          </p:cNvPr>
          <p:cNvSpPr txBox="1"/>
          <p:nvPr/>
        </p:nvSpPr>
        <p:spPr>
          <a:xfrm flipH="1">
            <a:off x="3514748" y="8413231"/>
            <a:ext cx="10647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solidFill>
                  <a:srgbClr val="FF0000"/>
                </a:solidFill>
                <a:latin typeface="等线" panose="02010600030101010101" pitchFamily="2" charset="-122"/>
                <a:ea typeface="等线" panose="02010600030101010101" pitchFamily="2" charset="-122"/>
              </a:rPr>
              <a:t>ⅹ</a:t>
            </a:r>
            <a:endParaRPr lang="zh-CN" altLang="en-US" sz="24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9905705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15">
            <a:extLst>
              <a:ext uri="{FF2B5EF4-FFF2-40B4-BE49-F238E27FC236}">
                <a16:creationId xmlns:a16="http://schemas.microsoft.com/office/drawing/2014/main" id="{49C1B967-2A39-4603-93E6-368272BDCB68}"/>
              </a:ext>
            </a:extLst>
          </p:cNvPr>
          <p:cNvSpPr txBox="1"/>
          <p:nvPr/>
        </p:nvSpPr>
        <p:spPr>
          <a:xfrm>
            <a:off x="810861" y="999512"/>
            <a:ext cx="2367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7B Fig, first panel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15">
            <a:extLst>
              <a:ext uri="{FF2B5EF4-FFF2-40B4-BE49-F238E27FC236}">
                <a16:creationId xmlns:a16="http://schemas.microsoft.com/office/drawing/2014/main" id="{49C1B967-2A39-4603-93E6-368272BDCB68}"/>
              </a:ext>
            </a:extLst>
          </p:cNvPr>
          <p:cNvSpPr txBox="1"/>
          <p:nvPr/>
        </p:nvSpPr>
        <p:spPr>
          <a:xfrm>
            <a:off x="4143743" y="999512"/>
            <a:ext cx="2367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7B Fig, second panel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15">
            <a:extLst>
              <a:ext uri="{FF2B5EF4-FFF2-40B4-BE49-F238E27FC236}">
                <a16:creationId xmlns:a16="http://schemas.microsoft.com/office/drawing/2014/main" id="{2640267F-F4DD-43ED-B283-29CE70E1E9F4}"/>
              </a:ext>
            </a:extLst>
          </p:cNvPr>
          <p:cNvSpPr txBox="1"/>
          <p:nvPr/>
        </p:nvSpPr>
        <p:spPr>
          <a:xfrm>
            <a:off x="818115" y="3024254"/>
            <a:ext cx="2367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7C Fig, first panel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D5DCE896-57A5-4B28-85B5-D1258EEAE7E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0861" y="3332031"/>
            <a:ext cx="2051304" cy="1438656"/>
          </a:xfrm>
          <a:prstGeom prst="rect">
            <a:avLst/>
          </a:prstGeom>
        </p:spPr>
      </p:pic>
      <p:sp>
        <p:nvSpPr>
          <p:cNvPr id="9" name="文本框 15">
            <a:extLst>
              <a:ext uri="{FF2B5EF4-FFF2-40B4-BE49-F238E27FC236}">
                <a16:creationId xmlns:a16="http://schemas.microsoft.com/office/drawing/2014/main" id="{F77B90F8-E060-4219-9F27-998822BEF4D3}"/>
              </a:ext>
            </a:extLst>
          </p:cNvPr>
          <p:cNvSpPr txBox="1"/>
          <p:nvPr/>
        </p:nvSpPr>
        <p:spPr>
          <a:xfrm>
            <a:off x="4143743" y="3017304"/>
            <a:ext cx="2367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7C Fig, second panel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BFD21619-495E-4642-83A6-B91749B5BBD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2614" y="3332031"/>
            <a:ext cx="2051304" cy="1438656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280D3D71-6BB1-424D-A3F9-51BE52036C9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0861" y="5649685"/>
            <a:ext cx="2051304" cy="1831848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9C7D2141-29B8-4F60-8E36-7056013ACB26}"/>
              </a:ext>
            </a:extLst>
          </p:cNvPr>
          <p:cNvSpPr txBox="1"/>
          <p:nvPr/>
        </p:nvSpPr>
        <p:spPr>
          <a:xfrm>
            <a:off x="810861" y="5056297"/>
            <a:ext cx="2367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7C Fig, third panel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B266CFF0-98E1-4C80-B270-5FF6382802BB}"/>
              </a:ext>
            </a:extLst>
          </p:cNvPr>
          <p:cNvSpPr txBox="1"/>
          <p:nvPr/>
        </p:nvSpPr>
        <p:spPr>
          <a:xfrm>
            <a:off x="14515" y="9202"/>
            <a:ext cx="20465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S7 Fig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A71A3981-E5B6-4B23-82B4-D7C49E0676E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155" y="1351170"/>
            <a:ext cx="3557016" cy="1441704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7E2D8205-14D5-4037-9C7D-4349FA8A11E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8459" y="1305450"/>
            <a:ext cx="3230880" cy="14874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9313760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15">
            <a:extLst>
              <a:ext uri="{FF2B5EF4-FFF2-40B4-BE49-F238E27FC236}">
                <a16:creationId xmlns:a16="http://schemas.microsoft.com/office/drawing/2014/main" id="{49C1B967-2A39-4603-93E6-368272BDCB68}"/>
              </a:ext>
            </a:extLst>
          </p:cNvPr>
          <p:cNvSpPr txBox="1"/>
          <p:nvPr/>
        </p:nvSpPr>
        <p:spPr>
          <a:xfrm>
            <a:off x="636688" y="561555"/>
            <a:ext cx="2367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8A Fig, first panel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15">
            <a:extLst>
              <a:ext uri="{FF2B5EF4-FFF2-40B4-BE49-F238E27FC236}">
                <a16:creationId xmlns:a16="http://schemas.microsoft.com/office/drawing/2014/main" id="{49C1B967-2A39-4603-93E6-368272BDCB68}"/>
              </a:ext>
            </a:extLst>
          </p:cNvPr>
          <p:cNvSpPr txBox="1"/>
          <p:nvPr/>
        </p:nvSpPr>
        <p:spPr>
          <a:xfrm>
            <a:off x="3853458" y="561554"/>
            <a:ext cx="2367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8A Fig, second panel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3CB7D6F5-8009-465B-A9FF-25C4986F27C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176" y="1077758"/>
            <a:ext cx="1987296" cy="1335024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8A850960-B408-4644-9F3F-07BD199D9AC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5357" y="1077758"/>
            <a:ext cx="1987296" cy="1335024"/>
          </a:xfrm>
          <a:prstGeom prst="rect">
            <a:avLst/>
          </a:prstGeom>
        </p:spPr>
      </p:pic>
      <p:sp>
        <p:nvSpPr>
          <p:cNvPr id="10" name="文本框 15">
            <a:extLst>
              <a:ext uri="{FF2B5EF4-FFF2-40B4-BE49-F238E27FC236}">
                <a16:creationId xmlns:a16="http://schemas.microsoft.com/office/drawing/2014/main" id="{1F35E074-3C20-4210-AD85-4815EE206897}"/>
              </a:ext>
            </a:extLst>
          </p:cNvPr>
          <p:cNvSpPr txBox="1"/>
          <p:nvPr/>
        </p:nvSpPr>
        <p:spPr>
          <a:xfrm>
            <a:off x="636688" y="2653937"/>
            <a:ext cx="2367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8A Fig, third panel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97FED853-C8BA-4EF0-968B-854F0D13235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176" y="3037044"/>
            <a:ext cx="1987296" cy="1898904"/>
          </a:xfrm>
          <a:prstGeom prst="rect">
            <a:avLst/>
          </a:prstGeom>
        </p:spPr>
      </p:pic>
      <p:sp>
        <p:nvSpPr>
          <p:cNvPr id="13" name="文本框 15">
            <a:extLst>
              <a:ext uri="{FF2B5EF4-FFF2-40B4-BE49-F238E27FC236}">
                <a16:creationId xmlns:a16="http://schemas.microsoft.com/office/drawing/2014/main" id="{FA42251D-656B-4CA7-BA8A-43E434FDD060}"/>
              </a:ext>
            </a:extLst>
          </p:cNvPr>
          <p:cNvSpPr txBox="1"/>
          <p:nvPr/>
        </p:nvSpPr>
        <p:spPr>
          <a:xfrm>
            <a:off x="3825357" y="2703797"/>
            <a:ext cx="2367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8D Fig, first panel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5">
            <a:extLst>
              <a:ext uri="{FF2B5EF4-FFF2-40B4-BE49-F238E27FC236}">
                <a16:creationId xmlns:a16="http://schemas.microsoft.com/office/drawing/2014/main" id="{3E54CD1E-96D2-42ED-BC50-FB39567FEB88}"/>
              </a:ext>
            </a:extLst>
          </p:cNvPr>
          <p:cNvSpPr txBox="1"/>
          <p:nvPr/>
        </p:nvSpPr>
        <p:spPr>
          <a:xfrm>
            <a:off x="636688" y="5299661"/>
            <a:ext cx="2367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8D Fig, second panel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52C22C6B-C6C7-4981-983D-F564EA287F2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7056" y="8020086"/>
            <a:ext cx="1987296" cy="1353312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38E4DA3C-A50A-4DFE-A794-FFAC84E662D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688" y="7991133"/>
            <a:ext cx="1987296" cy="1353312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CBBF7F2A-63F0-4B4E-A13F-AE4FCE4C182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7056" y="5786039"/>
            <a:ext cx="1987296" cy="1353312"/>
          </a:xfrm>
          <a:prstGeom prst="rect">
            <a:avLst/>
          </a:prstGeom>
        </p:spPr>
      </p:pic>
      <p:sp>
        <p:nvSpPr>
          <p:cNvPr id="23" name="文本框 15">
            <a:extLst>
              <a:ext uri="{FF2B5EF4-FFF2-40B4-BE49-F238E27FC236}">
                <a16:creationId xmlns:a16="http://schemas.microsoft.com/office/drawing/2014/main" id="{4CF02E8E-28A8-4FDD-A12B-D7A4E0DBC34E}"/>
              </a:ext>
            </a:extLst>
          </p:cNvPr>
          <p:cNvSpPr txBox="1"/>
          <p:nvPr/>
        </p:nvSpPr>
        <p:spPr>
          <a:xfrm>
            <a:off x="3825357" y="5295839"/>
            <a:ext cx="2367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8H Fig, first panel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15">
            <a:extLst>
              <a:ext uri="{FF2B5EF4-FFF2-40B4-BE49-F238E27FC236}">
                <a16:creationId xmlns:a16="http://schemas.microsoft.com/office/drawing/2014/main" id="{F8436381-BA30-4F39-B2BB-14E4A558EC45}"/>
              </a:ext>
            </a:extLst>
          </p:cNvPr>
          <p:cNvSpPr txBox="1"/>
          <p:nvPr/>
        </p:nvSpPr>
        <p:spPr>
          <a:xfrm>
            <a:off x="636688" y="7514011"/>
            <a:ext cx="2367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8H Fig, second panel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15">
            <a:extLst>
              <a:ext uri="{FF2B5EF4-FFF2-40B4-BE49-F238E27FC236}">
                <a16:creationId xmlns:a16="http://schemas.microsoft.com/office/drawing/2014/main" id="{16E6B524-E3CE-4201-9E56-B54D03F71EF8}"/>
              </a:ext>
            </a:extLst>
          </p:cNvPr>
          <p:cNvSpPr txBox="1"/>
          <p:nvPr/>
        </p:nvSpPr>
        <p:spPr>
          <a:xfrm>
            <a:off x="3825357" y="7514011"/>
            <a:ext cx="2367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8H Fig, third panel.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649F7673-4C1B-4A10-B681-C91F7BF966AF}"/>
              </a:ext>
            </a:extLst>
          </p:cNvPr>
          <p:cNvSpPr txBox="1"/>
          <p:nvPr/>
        </p:nvSpPr>
        <p:spPr>
          <a:xfrm>
            <a:off x="14515" y="9202"/>
            <a:ext cx="20465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S8 Fig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2C690235-BDF7-4F48-9F39-B78CE95A9DAC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176" y="5941691"/>
            <a:ext cx="1923288" cy="1274064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775EE8F2-4AD7-4477-835C-4E29225BCD2E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34386" y="3516674"/>
            <a:ext cx="1923288" cy="12740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71016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 algn="l">
          <a:defRPr sz="1000" dirty="0" smtClean="0">
            <a:solidFill>
              <a:schemeClr val="bg1"/>
            </a:solidFill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57</TotalTime>
  <Words>216</Words>
  <Application>Microsoft Office PowerPoint</Application>
  <PresentationFormat>A4 纸张(210x297 毫米)</PresentationFormat>
  <Paragraphs>45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2</vt:i4>
      </vt:variant>
      <vt:variant>
        <vt:lpstr>幻灯片标题</vt:lpstr>
      </vt:variant>
      <vt:variant>
        <vt:i4>7</vt:i4>
      </vt:variant>
    </vt:vector>
  </HeadingPairs>
  <TitlesOfParts>
    <vt:vector size="15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1_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hinkPad</dc:creator>
  <cp:lastModifiedBy>ThinkPad</cp:lastModifiedBy>
  <cp:revision>55</cp:revision>
  <dcterms:created xsi:type="dcterms:W3CDTF">2021-08-27T04:56:48Z</dcterms:created>
  <dcterms:modified xsi:type="dcterms:W3CDTF">2022-02-26T09:01:28Z</dcterms:modified>
</cp:coreProperties>
</file>